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0080625" cy="7559675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560000" cy="10692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" name="AutoShape 1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" name="PlaceHolder 1"/>
          <p:cNvSpPr>
            <a:spLocks noGrp="1"/>
          </p:cNvSpPr>
          <p:nvPr>
            <p:ph type="sldImg"/>
          </p:nvPr>
        </p:nvSpPr>
        <p:spPr>
          <a:xfrm>
            <a:off x="1106640" y="812880"/>
            <a:ext cx="5341680" cy="4005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body"/>
          </p:nvPr>
        </p:nvSpPr>
        <p:spPr>
          <a:xfrm>
            <a:off x="755640" y="5078160"/>
            <a:ext cx="6045120" cy="480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 type="hdr"/>
          </p:nvPr>
        </p:nvSpPr>
        <p:spPr>
          <a:xfrm>
            <a:off x="0" y="-360"/>
            <a:ext cx="3278160" cy="531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" name="PlaceHolder 4"/>
          <p:cNvSpPr>
            <a:spLocks noGrp="1"/>
          </p:cNvSpPr>
          <p:nvPr>
            <p:ph type="dt" idx="4"/>
          </p:nvPr>
        </p:nvSpPr>
        <p:spPr>
          <a:xfrm>
            <a:off x="4278240" y="-360"/>
            <a:ext cx="3278160" cy="531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" name="PlaceHolder 5"/>
          <p:cNvSpPr>
            <a:spLocks noGrp="1"/>
          </p:cNvSpPr>
          <p:nvPr>
            <p:ph type="ftr" idx="5"/>
          </p:nvPr>
        </p:nvSpPr>
        <p:spPr>
          <a:xfrm>
            <a:off x="0" y="10156680"/>
            <a:ext cx="3278160" cy="532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" name="PlaceHolder 6"/>
          <p:cNvSpPr>
            <a:spLocks noGrp="1"/>
          </p:cNvSpPr>
          <p:nvPr>
            <p:ph type="sldNum" idx="6"/>
          </p:nvPr>
        </p:nvSpPr>
        <p:spPr>
          <a:xfrm>
            <a:off x="4278240" y="10156680"/>
            <a:ext cx="3278160" cy="532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0869494A-C16A-4B21-803B-9BC1E5D7CDB8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Rectangle 7"/>
          <p:cNvSpPr/>
          <p:nvPr/>
        </p:nvSpPr>
        <p:spPr>
          <a:xfrm>
            <a:off x="4278240" y="10156680"/>
            <a:ext cx="3278160" cy="53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3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5E2085E9-34BB-4675-A3D7-78A1504F239C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9" name="PlaceHolder 1"/>
          <p:cNvSpPr>
            <a:spLocks noGrp="1"/>
          </p:cNvSpPr>
          <p:nvPr>
            <p:ph type="sldImg"/>
          </p:nvPr>
        </p:nvSpPr>
        <p:spPr>
          <a:xfrm>
            <a:off x="1106640" y="812880"/>
            <a:ext cx="5344920" cy="4008240"/>
          </a:xfrm>
          <a:prstGeom prst="rect">
            <a:avLst/>
          </a:prstGeom>
          <a:ln w="0">
            <a:noFill/>
          </a:ln>
        </p:spPr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755280" y="5078160"/>
            <a:ext cx="6046920" cy="4809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F7389A-FBB4-4D65-8C76-3C12BEBB46A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906768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03280" y="4372560"/>
            <a:ext cx="906768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143498-01E2-4DD3-9233-E6CC67BB5F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149800" y="17679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03280" y="43725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149800" y="43725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0B088D-215C-4E5C-A374-FE15CC31664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291960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69400" y="1767960"/>
            <a:ext cx="291960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35160" y="1767960"/>
            <a:ext cx="291960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03280" y="4372560"/>
            <a:ext cx="291960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69400" y="4372560"/>
            <a:ext cx="291960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35160" y="4372560"/>
            <a:ext cx="291960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576CA7-46AB-4DDE-A08A-E9F810DBBFE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3280" y="1767960"/>
            <a:ext cx="906768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FCAC5F-2D24-4FA0-8480-ABDFE52690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906768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7D5400-E368-4F7A-9C39-23F64E453F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76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149800" y="1767960"/>
            <a:ext cx="442476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F19D34-9807-4803-92CA-9C97371DBA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D3E1DC-6666-4BD3-AB30-261CA484DA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3280" y="301320"/>
            <a:ext cx="9067680" cy="583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5555F5-DB78-4B6A-B586-BBB36F523A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149800" y="1767960"/>
            <a:ext cx="442476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03280" y="43725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264BF7-0002-4EE5-9011-F05D35DA50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76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149800" y="17679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149800" y="43725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9FEE75-B918-4672-BDFD-5C42114C9B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149800" y="17679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03280" y="4372560"/>
            <a:ext cx="906768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9879DA-895E-4220-883D-2FEC0983AC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3280" y="1767960"/>
            <a:ext cx="906768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02920" y="6886440"/>
            <a:ext cx="2344680" cy="517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448080" y="6886440"/>
            <a:ext cx="3192480" cy="517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227720" y="6886440"/>
            <a:ext cx="2345040" cy="517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fld id="{C3C20295-140C-4728-BE4E-074C7A8D16F4}" type="slidenum">
              <a:rPr b="0" lang="en-US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 Box 1"/>
          <p:cNvSpPr/>
          <p:nvPr/>
        </p:nvSpPr>
        <p:spPr>
          <a:xfrm>
            <a:off x="2160720" y="216000"/>
            <a:ext cx="5219640" cy="323640"/>
          </a:xfrm>
          <a:prstGeom prst="rect">
            <a:avLst/>
          </a:prstGeom>
          <a:solidFill>
            <a:srgbClr val="ff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7240" bIns="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ffymetrix's GeneChip Bovine Genome Array (24128 probe sets)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" name="AutoShape 2"/>
          <p:cNvSpPr/>
          <p:nvPr/>
        </p:nvSpPr>
        <p:spPr>
          <a:xfrm>
            <a:off x="4514760" y="576360"/>
            <a:ext cx="438120" cy="507960"/>
          </a:xfrm>
          <a:prstGeom prst="downArrow">
            <a:avLst>
              <a:gd name="adj1" fmla="val 43241"/>
              <a:gd name="adj2" fmla="val 41330"/>
            </a:avLst>
          </a:prstGeom>
          <a:solidFill>
            <a:srgbClr val="4c4c4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" name="Text Box 3"/>
          <p:cNvSpPr/>
          <p:nvPr/>
        </p:nvSpPr>
        <p:spPr>
          <a:xfrm>
            <a:off x="2050920" y="1150920"/>
            <a:ext cx="5327640" cy="7207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7240" bIns="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library genefilter, function nsFilter()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: removal of probe sets with low variability, or without Entrez ID. In case of duplicates probe sets, removal of variants with lower variability.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" name="Text Box 4"/>
          <p:cNvSpPr/>
          <p:nvPr/>
        </p:nvSpPr>
        <p:spPr>
          <a:xfrm>
            <a:off x="3384720" y="2448000"/>
            <a:ext cx="2700000" cy="360360"/>
          </a:xfrm>
          <a:prstGeom prst="rect">
            <a:avLst/>
          </a:prstGeom>
          <a:solidFill>
            <a:srgbClr val="ff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7240" bIns="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8315 probe sets passed the filter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" name="AutoShape 5"/>
          <p:cNvSpPr/>
          <p:nvPr/>
        </p:nvSpPr>
        <p:spPr>
          <a:xfrm>
            <a:off x="4514760" y="1913040"/>
            <a:ext cx="438120" cy="507960"/>
          </a:xfrm>
          <a:prstGeom prst="downArrow">
            <a:avLst>
              <a:gd name="adj1" fmla="val 43241"/>
              <a:gd name="adj2" fmla="val 41330"/>
            </a:avLst>
          </a:prstGeom>
          <a:solidFill>
            <a:srgbClr val="4c4c4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" name="Text Box 6"/>
          <p:cNvSpPr/>
          <p:nvPr/>
        </p:nvSpPr>
        <p:spPr>
          <a:xfrm>
            <a:off x="2482920" y="3348000"/>
            <a:ext cx="4500360" cy="4906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7240" bIns="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library genefilter, t-test filtering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ritical value P=0.05, uncorrected for multiple comparisons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5" name="AutoShape 7"/>
          <p:cNvSpPr/>
          <p:nvPr/>
        </p:nvSpPr>
        <p:spPr>
          <a:xfrm>
            <a:off x="4514760" y="2816280"/>
            <a:ext cx="438120" cy="509400"/>
          </a:xfrm>
          <a:prstGeom prst="downArrow">
            <a:avLst>
              <a:gd name="adj1" fmla="val 43241"/>
              <a:gd name="adj2" fmla="val 41448"/>
            </a:avLst>
          </a:prstGeom>
          <a:solidFill>
            <a:srgbClr val="4c4c4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56" name="Group 8"/>
          <p:cNvGrpSpPr/>
          <p:nvPr/>
        </p:nvGrpSpPr>
        <p:grpSpPr>
          <a:xfrm>
            <a:off x="1224000" y="4464000"/>
            <a:ext cx="7018200" cy="358920"/>
            <a:chOff x="1224000" y="4464000"/>
            <a:chExt cx="7018200" cy="358920"/>
          </a:xfrm>
        </p:grpSpPr>
        <p:sp>
          <p:nvSpPr>
            <p:cNvPr id="57" name="Rectangle 9"/>
            <p:cNvSpPr/>
            <p:nvPr/>
          </p:nvSpPr>
          <p:spPr>
            <a:xfrm>
              <a:off x="1224000" y="4464000"/>
              <a:ext cx="7018200" cy="358920"/>
            </a:xfrm>
            <a:prstGeom prst="rect">
              <a:avLst/>
            </a:prstGeom>
            <a:solidFill>
              <a:srgbClr val="ff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8" name="Text Box 10"/>
            <p:cNvSpPr/>
            <p:nvPr/>
          </p:nvSpPr>
          <p:spPr>
            <a:xfrm>
              <a:off x="3202920" y="4464000"/>
              <a:ext cx="3418200" cy="358920"/>
            </a:xfrm>
            <a:prstGeom prst="rect">
              <a:avLst/>
            </a:prstGeom>
            <a:solidFill>
              <a:srgbClr val="ff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50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5930 probe sets passed the filter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59" name="AutoShape 11"/>
          <p:cNvSpPr/>
          <p:nvPr/>
        </p:nvSpPr>
        <p:spPr>
          <a:xfrm>
            <a:off x="4514760" y="3906720"/>
            <a:ext cx="438120" cy="507960"/>
          </a:xfrm>
          <a:prstGeom prst="downArrow">
            <a:avLst>
              <a:gd name="adj1" fmla="val 43241"/>
              <a:gd name="adj2" fmla="val 41330"/>
            </a:avLst>
          </a:prstGeom>
          <a:solidFill>
            <a:srgbClr val="4c4c4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0" name="Text Box 12"/>
          <p:cNvSpPr/>
          <p:nvPr/>
        </p:nvSpPr>
        <p:spPr>
          <a:xfrm>
            <a:off x="108000" y="5450040"/>
            <a:ext cx="4319640" cy="6886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7240" bIns="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library limma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riteria for significance: adjusted P value &lt; 0.05, absolute fold-change greater or equal to 2.5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1" name="AutoShape 13"/>
          <p:cNvSpPr/>
          <p:nvPr/>
        </p:nvSpPr>
        <p:spPr>
          <a:xfrm>
            <a:off x="1836720" y="4879800"/>
            <a:ext cx="434880" cy="508320"/>
          </a:xfrm>
          <a:prstGeom prst="downArrow">
            <a:avLst>
              <a:gd name="adj1" fmla="val 43241"/>
              <a:gd name="adj2" fmla="val 41668"/>
            </a:avLst>
          </a:prstGeom>
          <a:solidFill>
            <a:srgbClr val="4c4c4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2" name="AutoShape 14"/>
          <p:cNvSpPr/>
          <p:nvPr/>
        </p:nvSpPr>
        <p:spPr>
          <a:xfrm>
            <a:off x="7101000" y="4879800"/>
            <a:ext cx="436320" cy="508320"/>
          </a:xfrm>
          <a:prstGeom prst="downArrow">
            <a:avLst>
              <a:gd name="adj1" fmla="val 43241"/>
              <a:gd name="adj2" fmla="val 41530"/>
            </a:avLst>
          </a:prstGeom>
          <a:solidFill>
            <a:srgbClr val="4c4c4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3" name="Text Box 15"/>
          <p:cNvSpPr/>
          <p:nvPr/>
        </p:nvSpPr>
        <p:spPr>
          <a:xfrm>
            <a:off x="4645080" y="5450040"/>
            <a:ext cx="5040360" cy="6886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7240" bIns="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ene set enrichment analysis, library GSEABase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Only KEGG pathways represented by at least 11 genes with a fold-change greater or equal to 1.5 were considered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4" name="AutoShape 16"/>
          <p:cNvSpPr/>
          <p:nvPr/>
        </p:nvSpPr>
        <p:spPr>
          <a:xfrm>
            <a:off x="1835280" y="6224760"/>
            <a:ext cx="434880" cy="507960"/>
          </a:xfrm>
          <a:prstGeom prst="downArrow">
            <a:avLst>
              <a:gd name="adj1" fmla="val 43241"/>
              <a:gd name="adj2" fmla="val 41638"/>
            </a:avLst>
          </a:prstGeom>
          <a:solidFill>
            <a:srgbClr val="4c4c4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5" name="Text Box 17"/>
          <p:cNvSpPr/>
          <p:nvPr/>
        </p:nvSpPr>
        <p:spPr>
          <a:xfrm>
            <a:off x="792000" y="6804000"/>
            <a:ext cx="2519640" cy="503280"/>
          </a:xfrm>
          <a:prstGeom prst="rect">
            <a:avLst/>
          </a:prstGeom>
          <a:solidFill>
            <a:srgbClr val="ff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7240" bIns="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48 probe sets down-regulated, 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4 up-regulated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" name="AutoShape 18"/>
          <p:cNvSpPr/>
          <p:nvPr/>
        </p:nvSpPr>
        <p:spPr>
          <a:xfrm>
            <a:off x="7124760" y="6188040"/>
            <a:ext cx="434880" cy="507960"/>
          </a:xfrm>
          <a:prstGeom prst="downArrow">
            <a:avLst>
              <a:gd name="adj1" fmla="val 43241"/>
              <a:gd name="adj2" fmla="val 41638"/>
            </a:avLst>
          </a:prstGeom>
          <a:solidFill>
            <a:srgbClr val="4c4c4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" name="Text Box 19"/>
          <p:cNvSpPr/>
          <p:nvPr/>
        </p:nvSpPr>
        <p:spPr>
          <a:xfrm>
            <a:off x="5940360" y="6804000"/>
            <a:ext cx="2808360" cy="503280"/>
          </a:xfrm>
          <a:prstGeom prst="rect">
            <a:avLst/>
          </a:prstGeom>
          <a:solidFill>
            <a:srgbClr val="ff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7240" bIns="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59 probe sets in 15 differentially 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xpressed pathways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4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27T00:14:00Z</dcterms:created>
  <dc:creator>Marcelo Soria</dc:creator>
  <dc:description/>
  <dc:language>en-US</dc:language>
  <cp:lastModifiedBy>Fabiana Bigi</cp:lastModifiedBy>
  <dcterms:modified xsi:type="dcterms:W3CDTF">2012-04-24T17:44:59Z</dcterms:modified>
  <cp:revision>2</cp:revision>
  <dc:subject/>
  <dc:title>Diapositiva 1</dc:title>
</cp:coreProperties>
</file>